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horzBarState="maximized">
    <p:restoredLeft sz="15620"/>
    <p:restoredTop sz="99841" autoAdjust="0"/>
  </p:normalViewPr>
  <p:slideViewPr>
    <p:cSldViewPr snapToGrid="0" snapToObjects="1">
      <p:cViewPr>
        <p:scale>
          <a:sx n="200" d="100"/>
          <a:sy n="200" d="100"/>
        </p:scale>
        <p:origin x="56" y="700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50" d="100"/>
        <a:sy n="15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1BF476-B0E2-1F44-A9EE-045010E59F79}" type="datetimeFigureOut">
              <a:rPr lang="en-US" smtClean="0"/>
              <a:t>8/1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618FE8-F36B-5543-83B3-7CFF859B0A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49255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1BF476-B0E2-1F44-A9EE-045010E59F79}" type="datetimeFigureOut">
              <a:rPr lang="en-US" smtClean="0"/>
              <a:t>8/1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618FE8-F36B-5543-83B3-7CFF859B0A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65021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1BF476-B0E2-1F44-A9EE-045010E59F79}" type="datetimeFigureOut">
              <a:rPr lang="en-US" smtClean="0"/>
              <a:t>8/1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618FE8-F36B-5543-83B3-7CFF859B0A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6835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1BF476-B0E2-1F44-A9EE-045010E59F79}" type="datetimeFigureOut">
              <a:rPr lang="en-US" smtClean="0"/>
              <a:t>8/1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618FE8-F36B-5543-83B3-7CFF859B0A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01247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1BF476-B0E2-1F44-A9EE-045010E59F79}" type="datetimeFigureOut">
              <a:rPr lang="en-US" smtClean="0"/>
              <a:t>8/1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618FE8-F36B-5543-83B3-7CFF859B0A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95504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1BF476-B0E2-1F44-A9EE-045010E59F79}" type="datetimeFigureOut">
              <a:rPr lang="en-US" smtClean="0"/>
              <a:t>8/10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618FE8-F36B-5543-83B3-7CFF859B0A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67455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1BF476-B0E2-1F44-A9EE-045010E59F79}" type="datetimeFigureOut">
              <a:rPr lang="en-US" smtClean="0"/>
              <a:t>8/10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618FE8-F36B-5543-83B3-7CFF859B0A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0801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1BF476-B0E2-1F44-A9EE-045010E59F79}" type="datetimeFigureOut">
              <a:rPr lang="en-US" smtClean="0"/>
              <a:t>8/10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618FE8-F36B-5543-83B3-7CFF859B0A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03466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1BF476-B0E2-1F44-A9EE-045010E59F79}" type="datetimeFigureOut">
              <a:rPr lang="en-US" smtClean="0"/>
              <a:t>8/10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618FE8-F36B-5543-83B3-7CFF859B0A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4958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1BF476-B0E2-1F44-A9EE-045010E59F79}" type="datetimeFigureOut">
              <a:rPr lang="en-US" smtClean="0"/>
              <a:t>8/10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618FE8-F36B-5543-83B3-7CFF859B0A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54417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1BF476-B0E2-1F44-A9EE-045010E59F79}" type="datetimeFigureOut">
              <a:rPr lang="en-US" smtClean="0"/>
              <a:t>8/10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618FE8-F36B-5543-83B3-7CFF859B0A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76928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1BF476-B0E2-1F44-A9EE-045010E59F79}" type="datetimeFigureOut">
              <a:rPr lang="en-US" smtClean="0"/>
              <a:t>8/1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618FE8-F36B-5543-83B3-7CFF859B0A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53378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19047417"/>
              </p:ext>
            </p:extLst>
          </p:nvPr>
        </p:nvGraphicFramePr>
        <p:xfrm>
          <a:off x="400050" y="1354614"/>
          <a:ext cx="6057900" cy="1623060"/>
        </p:xfrm>
        <a:graphic>
          <a:graphicData uri="http://schemas.openxmlformats.org/drawingml/2006/table">
            <a:tbl>
              <a:tblPr/>
              <a:tblGrid>
                <a:gridCol w="673100"/>
                <a:gridCol w="673100"/>
                <a:gridCol w="673100"/>
                <a:gridCol w="673100"/>
                <a:gridCol w="673100"/>
                <a:gridCol w="673100"/>
                <a:gridCol w="673100"/>
                <a:gridCol w="673100"/>
                <a:gridCol w="673100"/>
              </a:tblGrid>
              <a:tr h="177800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 uM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5 uM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25 uM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625 uM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3125 uM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56 uM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78 uM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 uM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78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 </a:t>
                      </a:r>
                      <a:r>
                        <a:rPr lang="en-US" sz="11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uM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000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4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0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0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0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0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0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</a:tr>
              <a:tr h="1778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5 uM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000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900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949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7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0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0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0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0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</a:tr>
              <a:tr h="1778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25 uM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4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949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000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83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29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3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0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</a:tr>
              <a:tr h="1778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625 uM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0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7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000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000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000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561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3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</a:tr>
              <a:tr h="1778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3125 uM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0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0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83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000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000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000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64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78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56 uM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0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0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29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000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000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000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374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78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78 uM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0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0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3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561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000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000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000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78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 uM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0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0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0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3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64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374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000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262833" y="766233"/>
            <a:ext cx="2779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A</a:t>
            </a:r>
            <a:endParaRPr lang="en-US" sz="1200" b="1" dirty="0"/>
          </a:p>
        </p:txBody>
      </p:sp>
      <p:sp>
        <p:nvSpPr>
          <p:cNvPr id="6" name="TextBox 5"/>
          <p:cNvSpPr txBox="1"/>
          <p:nvPr/>
        </p:nvSpPr>
        <p:spPr>
          <a:xfrm>
            <a:off x="598899" y="780133"/>
            <a:ext cx="458270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Comparisons of cellular viability between concentrations of </a:t>
            </a:r>
            <a:r>
              <a:rPr lang="en-US" sz="1200" dirty="0" err="1" smtClean="0"/>
              <a:t>cisplatin</a:t>
            </a:r>
            <a:r>
              <a:rPr lang="en-US" sz="1200" dirty="0" smtClean="0"/>
              <a:t>. Two-way fixed factor ANOVA with REGWQ post-hoc</a:t>
            </a:r>
            <a:endParaRPr lang="en-US" sz="1200" dirty="0"/>
          </a:p>
        </p:txBody>
      </p:sp>
      <p:sp>
        <p:nvSpPr>
          <p:cNvPr id="7" name="TextBox 6"/>
          <p:cNvSpPr txBox="1"/>
          <p:nvPr/>
        </p:nvSpPr>
        <p:spPr>
          <a:xfrm>
            <a:off x="220501" y="3272351"/>
            <a:ext cx="274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B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556566" y="3286251"/>
            <a:ext cx="527696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Comparisons of cellular viability between cell lines. Two-way fixed factor ANOVA with REGWQ post-hoc</a:t>
            </a:r>
            <a:endParaRPr lang="en-US" sz="1200" dirty="0"/>
          </a:p>
        </p:txBody>
      </p:sp>
      <p:graphicFrame>
        <p:nvGraphicFramePr>
          <p:cNvPr id="9" name="Table 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80588613"/>
              </p:ext>
            </p:extLst>
          </p:nvPr>
        </p:nvGraphicFramePr>
        <p:xfrm>
          <a:off x="556566" y="3842106"/>
          <a:ext cx="4711700" cy="1262380"/>
        </p:xfrm>
        <a:graphic>
          <a:graphicData uri="http://schemas.openxmlformats.org/drawingml/2006/table">
            <a:tbl>
              <a:tblPr/>
              <a:tblGrid>
                <a:gridCol w="673100"/>
                <a:gridCol w="673100"/>
                <a:gridCol w="673100"/>
                <a:gridCol w="673100"/>
                <a:gridCol w="673100"/>
                <a:gridCol w="673100"/>
                <a:gridCol w="673100"/>
              </a:tblGrid>
              <a:tr h="177800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Ovcar5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2780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eyA8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kov3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Ovcar8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Igrov1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78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Ovcar5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836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11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37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000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778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78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2780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836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0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0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11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000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78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eyA8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11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0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000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878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0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</a:tr>
              <a:tr h="1778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kov3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37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0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000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000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0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</a:tr>
              <a:tr h="1778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Ovcar8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000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11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878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000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10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</a:tr>
              <a:tr h="1778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Igrov1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778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000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0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0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10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1744526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9</TotalTime>
  <Words>164</Words>
  <Application>Microsoft Office PowerPoint</Application>
  <PresentationFormat>On-screen Show (4:3)</PresentationFormat>
  <Paragraphs>13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NIH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ristina Annunziata</dc:creator>
  <cp:lastModifiedBy>Abella, Jerard Dave</cp:lastModifiedBy>
  <cp:revision>10</cp:revision>
  <dcterms:created xsi:type="dcterms:W3CDTF">2016-07-20T06:20:14Z</dcterms:created>
  <dcterms:modified xsi:type="dcterms:W3CDTF">2016-08-10T10:56:34Z</dcterms:modified>
</cp:coreProperties>
</file>